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107" autoAdjust="0"/>
    <p:restoredTop sz="94660"/>
  </p:normalViewPr>
  <p:slideViewPr>
    <p:cSldViewPr snapToGrid="0">
      <p:cViewPr>
        <p:scale>
          <a:sx n="75" d="100"/>
          <a:sy n="75" d="100"/>
        </p:scale>
        <p:origin x="356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40243B-C9D9-4E37-8A9B-975BA07140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A714692-240B-41C5-8C90-F164BAD8D7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9EF380-C5C3-4129-8EEE-D4E623AC83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BB1000-A6C0-4C62-B2EA-1FD1D9783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E3F364-DC77-44FD-8491-23302B6B04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0617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F54C79-CE91-4E61-8E4D-D33854ED0B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6DFD16E-473E-4D8B-A930-A65036E800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7A1B09-20F6-48E8-B7A4-59C60E4C61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D38E91-8B3C-42C4-81BA-2A528F65A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78CFB91-036B-455E-ADB7-9BCA99A456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9755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AF64375-249E-4A22-B075-930765B156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0D4BDBB-E397-401F-81CC-ACD122A422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B2B769-92F2-4A7C-A9AE-92647EE79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978F82-22F3-4700-905C-B8BF30FA6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8A028F0-7A7E-4402-8B38-E013B57CE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09455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D32A81-633D-4770-80E3-A7A9DDD1B4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7CBB39-00E4-41AC-A959-E946ABF615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6656EC8-08E9-44FD-BCFA-0F41EB319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F44FEB1-A99B-445C-9FDD-26525761A8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D1EB348-1246-4E52-9BF8-63186A6036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8570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2F3AAD-9A47-4021-9DD9-6228DA476D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704A4F6-104B-419C-BB48-F4C993E0F8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6BA6A41-D01F-42A5-A0CB-C3858E782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B6E1E1-1D4E-46ED-ABE7-9809687FEE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CF9A44-A457-4832-BF3D-DD4F4B1600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9452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DFBED2-9502-4A6E-9B63-6FD5D4C813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838064D-07F7-4F1C-B27F-2EBBE2CB19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0ADBD82-67F9-480E-9432-3763B19B37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D2A9A7C-C81A-4CA4-975E-A60478CCD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D52C19B-593E-4BA2-BB98-C13F53285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F69C6D4-056C-4CB7-A498-2298945DB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7511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32F730-5371-47F1-B409-A5EA0A7D76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17530FC-E9BF-4073-8401-C6C23EF02B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0936AD0-1C01-439A-B5AA-D0CF7C96CD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027F032-1417-4983-B5B7-DBC3D6FFD9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1EC7F1C-5D7C-4352-B083-8B2D581E6D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578B67B-AF5E-4672-9A72-D4789F00B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85725B8-1C48-419D-B7F3-8927ABCAAC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82102D0-C63F-4A18-A7D1-BA31B9A89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6365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659908-829A-456D-96A3-24686DDA2F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A86B67D-AF34-4215-A1F8-513DA4717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00DA581-5376-4789-9A85-EE2D12191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AB3051E-C5C3-47E4-A22A-EB298DC97F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97172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2BEF6F9-93DC-4307-9D39-F0E43AF5A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D19725D-91E4-4FEE-8026-BE495B9B6D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6FA0E68-5D0B-4062-AD51-69B71FEFA3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55522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426F6B-2031-490C-A5A1-65A46833B0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25BFA83-4F0E-48B7-A0D0-99003B0259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635C5ED-0C58-4A9C-AFAC-BDAC71E895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0E7E3A4-5DDB-4572-BEE1-ADA34AA13F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EC9AD49-1057-4906-AD26-A3BF50F48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4353386-48BC-441A-AF4F-EA28190F8A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3293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4EF8F9-F59E-4069-8FE5-2FE2FE57F4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2A3F154-31B2-4BEE-94E9-6B8D74BAAF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C1A9FAF-7263-4725-A1FD-9E39D8EFA0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C23A9AF-2003-4B75-81D2-AA19AE85A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F697D45-5293-4E16-AD0B-CFCBA799F8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6DA7F62-83E4-4285-8BB4-718119A4D6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2479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46B0D66-E7A9-404C-802C-1EBC6B2DEF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63C41F8-CAC3-4F72-B536-F69A4C9D7F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62B3CA-E3A6-4CCE-9F05-A2E288C4AB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5B4F2E-532A-4F73-B9F5-358176767DC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FCDDD7-43F4-42EC-A33C-A6605D4619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6141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76EE6B4-FAF4-45AD-8965-1C8C1CC7A911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2C</a:t>
            </a:r>
            <a:endParaRPr lang="zh-CN" altLang="en-US" dirty="0"/>
          </a:p>
        </p:txBody>
      </p:sp>
      <p:graphicFrame>
        <p:nvGraphicFramePr>
          <p:cNvPr id="7" name="表格 6">
            <a:extLst>
              <a:ext uri="{FF2B5EF4-FFF2-40B4-BE49-F238E27FC236}">
                <a16:creationId xmlns:a16="http://schemas.microsoft.com/office/drawing/2014/main" id="{52F9CE6D-31C0-43D9-B033-6CCC7E5A8C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41574633"/>
              </p:ext>
            </p:extLst>
          </p:nvPr>
        </p:nvGraphicFramePr>
        <p:xfrm>
          <a:off x="1165761" y="3537743"/>
          <a:ext cx="8534400" cy="1968341"/>
        </p:xfrm>
        <a:graphic>
          <a:graphicData uri="http://schemas.openxmlformats.org/drawingml/2006/table">
            <a:tbl>
              <a:tblPr/>
              <a:tblGrid>
                <a:gridCol w="533400">
                  <a:extLst>
                    <a:ext uri="{9D8B030D-6E8A-4147-A177-3AD203B41FA5}">
                      <a16:colId xmlns:a16="http://schemas.microsoft.com/office/drawing/2014/main" val="905399949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423084885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4111464628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033204593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081695156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552014423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4257222574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349239205"/>
                    </a:ext>
                  </a:extLst>
                </a:gridCol>
              </a:tblGrid>
              <a:tr h="386557"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control shRNA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estrin2 shRNA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54393117"/>
                  </a:ext>
                </a:extLst>
              </a:tr>
              <a:tr h="395446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2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3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1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2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1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63769"/>
                  </a:ext>
                </a:extLst>
              </a:tr>
              <a:tr h="395446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7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8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4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6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7760722"/>
                  </a:ext>
                </a:extLst>
              </a:tr>
              <a:tr h="395446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74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79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76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0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6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3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9232148"/>
                  </a:ext>
                </a:extLst>
              </a:tr>
              <a:tr h="395446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11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99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1.08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6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5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6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3632731"/>
                  </a:ext>
                </a:extLst>
              </a:tr>
            </a:tbl>
          </a:graphicData>
        </a:graphic>
      </p:graphicFrame>
      <p:sp>
        <p:nvSpPr>
          <p:cNvPr id="8" name="文本框 7">
            <a:extLst>
              <a:ext uri="{FF2B5EF4-FFF2-40B4-BE49-F238E27FC236}">
                <a16:creationId xmlns:a16="http://schemas.microsoft.com/office/drawing/2014/main" id="{E54B3A36-A6D5-496A-B46F-52ED25CDACA9}"/>
              </a:ext>
            </a:extLst>
          </p:cNvPr>
          <p:cNvSpPr txBox="1"/>
          <p:nvPr/>
        </p:nvSpPr>
        <p:spPr>
          <a:xfrm>
            <a:off x="5394861" y="241339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is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CAA91D68-2F07-4C3F-929C-13AE4C8FC6E7}"/>
              </a:ext>
            </a:extLst>
          </p:cNvPr>
          <p:cNvSpPr txBox="1"/>
          <p:nvPr/>
        </p:nvSpPr>
        <p:spPr>
          <a:xfrm>
            <a:off x="5071011" y="5818226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G-63</a:t>
            </a:r>
            <a:endParaRPr lang="zh-CN" altLang="en-US" dirty="0"/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D1D7548C-7E7A-4280-83C1-5BF61A1D9A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62923" y="839132"/>
            <a:ext cx="3511550" cy="2470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357403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76EE6B4-FAF4-45AD-8965-1C8C1CC7A911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2H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B968B3A-5E33-4869-AA0B-A9A6A692A2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35425" y="669925"/>
            <a:ext cx="3511550" cy="247015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DCCDA4B8-AF22-4E80-939E-62DF32FFA501}"/>
              </a:ext>
            </a:extLst>
          </p:cNvPr>
          <p:cNvSpPr txBox="1"/>
          <p:nvPr/>
        </p:nvSpPr>
        <p:spPr>
          <a:xfrm>
            <a:off x="5071011" y="5818226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OS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9D8921D6-E791-490E-BA14-B23A2D43EA48}"/>
              </a:ext>
            </a:extLst>
          </p:cNvPr>
          <p:cNvSpPr txBox="1"/>
          <p:nvPr/>
        </p:nvSpPr>
        <p:spPr>
          <a:xfrm>
            <a:off x="5347236" y="241339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is</a:t>
            </a:r>
            <a:endParaRPr lang="zh-CN" altLang="en-US" dirty="0"/>
          </a:p>
        </p:txBody>
      </p:sp>
      <p:graphicFrame>
        <p:nvGraphicFramePr>
          <p:cNvPr id="7" name="表格 6">
            <a:extLst>
              <a:ext uri="{FF2B5EF4-FFF2-40B4-BE49-F238E27FC236}">
                <a16:creationId xmlns:a16="http://schemas.microsoft.com/office/drawing/2014/main" id="{EE971616-0A05-42B0-A33B-0B0F3910FC8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0925649"/>
              </p:ext>
            </p:extLst>
          </p:nvPr>
        </p:nvGraphicFramePr>
        <p:xfrm>
          <a:off x="1828800" y="3604419"/>
          <a:ext cx="8534400" cy="1739105"/>
        </p:xfrm>
        <a:graphic>
          <a:graphicData uri="http://schemas.openxmlformats.org/drawingml/2006/table">
            <a:tbl>
              <a:tblPr/>
              <a:tblGrid>
                <a:gridCol w="533400">
                  <a:extLst>
                    <a:ext uri="{9D8B030D-6E8A-4147-A177-3AD203B41FA5}">
                      <a16:colId xmlns:a16="http://schemas.microsoft.com/office/drawing/2014/main" val="1245003009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476258865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873089418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250269093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57434003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613685041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027235284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201134047"/>
                    </a:ext>
                  </a:extLst>
                </a:gridCol>
              </a:tblGrid>
              <a:tr h="347821"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HBLV sestrin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HBLV contro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13400209"/>
                  </a:ext>
                </a:extLst>
              </a:tr>
              <a:tr h="34782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3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8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18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19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0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18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840285"/>
                  </a:ext>
                </a:extLst>
              </a:tr>
              <a:tr h="34782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1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9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2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8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8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9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6031088"/>
                  </a:ext>
                </a:extLst>
              </a:tr>
              <a:tr h="34782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61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55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66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5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7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8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1865904"/>
                  </a:ext>
                </a:extLst>
              </a:tr>
              <a:tr h="34782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29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21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12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52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54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9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501085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2627469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76EE6B4-FAF4-45AD-8965-1C8C1CC7A911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2H</a:t>
            </a: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4E758453-A212-44FE-83BF-39E5361579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39148" y="610671"/>
            <a:ext cx="3511550" cy="247015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251FB40D-FD09-4160-AEAA-38FD29BF6404}"/>
              </a:ext>
            </a:extLst>
          </p:cNvPr>
          <p:cNvSpPr txBox="1"/>
          <p:nvPr/>
        </p:nvSpPr>
        <p:spPr>
          <a:xfrm>
            <a:off x="5071011" y="5818226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OS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B7CCC8E2-146B-492D-B77C-73A817D3A448}"/>
              </a:ext>
            </a:extLst>
          </p:cNvPr>
          <p:cNvSpPr txBox="1"/>
          <p:nvPr/>
        </p:nvSpPr>
        <p:spPr>
          <a:xfrm>
            <a:off x="5347236" y="241339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ox</a:t>
            </a:r>
            <a:endParaRPr lang="zh-CN" altLang="en-US" dirty="0"/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C5E22F23-8C0E-41E0-8506-235BE3FAE54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4876883"/>
              </p:ext>
            </p:extLst>
          </p:nvPr>
        </p:nvGraphicFramePr>
        <p:xfrm>
          <a:off x="1828800" y="3604419"/>
          <a:ext cx="8534400" cy="1796255"/>
        </p:xfrm>
        <a:graphic>
          <a:graphicData uri="http://schemas.openxmlformats.org/drawingml/2006/table">
            <a:tbl>
              <a:tblPr/>
              <a:tblGrid>
                <a:gridCol w="533400">
                  <a:extLst>
                    <a:ext uri="{9D8B030D-6E8A-4147-A177-3AD203B41FA5}">
                      <a16:colId xmlns:a16="http://schemas.microsoft.com/office/drawing/2014/main" val="1661703984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423736944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497913142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82206175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083996285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98479172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243697696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4074785105"/>
                    </a:ext>
                  </a:extLst>
                </a:gridCol>
              </a:tblGrid>
              <a:tr h="359251"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HBLV sestrin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HBLV contro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3037275"/>
                  </a:ext>
                </a:extLst>
              </a:tr>
              <a:tr h="35925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18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16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0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0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19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4260789"/>
                  </a:ext>
                </a:extLst>
              </a:tr>
              <a:tr h="35925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4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1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2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3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3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3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5312500"/>
                  </a:ext>
                </a:extLst>
              </a:tr>
              <a:tr h="35925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88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89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88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9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50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8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6398610"/>
                  </a:ext>
                </a:extLst>
              </a:tr>
              <a:tr h="35925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33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25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17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5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51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62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63734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9980653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76EE6B4-FAF4-45AD-8965-1C8C1CC7A911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2H</a:t>
            </a: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F58721A3-4799-40F6-BBC9-820521C92F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97325" y="610671"/>
            <a:ext cx="3511550" cy="247015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6F91F45A-8573-4F1A-A797-DB83E71D1EE1}"/>
              </a:ext>
            </a:extLst>
          </p:cNvPr>
          <p:cNvSpPr txBox="1"/>
          <p:nvPr/>
        </p:nvSpPr>
        <p:spPr>
          <a:xfrm>
            <a:off x="5071011" y="5818226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OS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92F946CE-46CF-416C-BCA6-E10AFF15CC2A}"/>
              </a:ext>
            </a:extLst>
          </p:cNvPr>
          <p:cNvSpPr txBox="1"/>
          <p:nvPr/>
        </p:nvSpPr>
        <p:spPr>
          <a:xfrm>
            <a:off x="5347236" y="241339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Mtx</a:t>
            </a:r>
            <a:endParaRPr lang="zh-CN" altLang="en-US" dirty="0"/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9656CB43-E4FE-46D2-9B17-D3A24C4AC69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1494728"/>
              </p:ext>
            </p:extLst>
          </p:nvPr>
        </p:nvGraphicFramePr>
        <p:xfrm>
          <a:off x="1828800" y="3604419"/>
          <a:ext cx="8534400" cy="1758155"/>
        </p:xfrm>
        <a:graphic>
          <a:graphicData uri="http://schemas.openxmlformats.org/drawingml/2006/table">
            <a:tbl>
              <a:tblPr/>
              <a:tblGrid>
                <a:gridCol w="533400">
                  <a:extLst>
                    <a:ext uri="{9D8B030D-6E8A-4147-A177-3AD203B41FA5}">
                      <a16:colId xmlns:a16="http://schemas.microsoft.com/office/drawing/2014/main" val="1190423393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031072641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578397693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4165783386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739420917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093751938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99555822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34719252"/>
                    </a:ext>
                  </a:extLst>
                </a:gridCol>
              </a:tblGrid>
              <a:tr h="351631"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HBLV sestrin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HBLV contro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61666921"/>
                  </a:ext>
                </a:extLst>
              </a:tr>
              <a:tr h="35163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17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6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17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19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2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0806478"/>
                  </a:ext>
                </a:extLst>
              </a:tr>
              <a:tr h="35163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8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4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5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4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5036381"/>
                  </a:ext>
                </a:extLst>
              </a:tr>
              <a:tr h="35163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92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88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96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8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50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6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9861159"/>
                  </a:ext>
                </a:extLst>
              </a:tr>
              <a:tr h="35163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39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29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2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5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54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035021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6109469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5981E30-44F0-4A4A-8441-36555543AD6C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3B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551CFFA0-5AC2-4681-81D7-F33DBF693B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43350" y="657224"/>
            <a:ext cx="3505200" cy="2863850"/>
          </a:xfrm>
          <a:prstGeom prst="rect">
            <a:avLst/>
          </a:prstGeom>
        </p:spPr>
      </p:pic>
      <p:graphicFrame>
        <p:nvGraphicFramePr>
          <p:cNvPr id="6" name="表格 5">
            <a:extLst>
              <a:ext uri="{FF2B5EF4-FFF2-40B4-BE49-F238E27FC236}">
                <a16:creationId xmlns:a16="http://schemas.microsoft.com/office/drawing/2014/main" id="{6DE751BD-93DD-4C1E-8B39-03CD719813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71421466"/>
              </p:ext>
            </p:extLst>
          </p:nvPr>
        </p:nvGraphicFramePr>
        <p:xfrm>
          <a:off x="2390775" y="4080668"/>
          <a:ext cx="6858000" cy="1405730"/>
        </p:xfrm>
        <a:graphic>
          <a:graphicData uri="http://schemas.openxmlformats.org/drawingml/2006/table">
            <a:tbl>
              <a:tblPr/>
              <a:tblGrid>
                <a:gridCol w="1143000">
                  <a:extLst>
                    <a:ext uri="{9D8B030D-6E8A-4147-A177-3AD203B41FA5}">
                      <a16:colId xmlns:a16="http://schemas.microsoft.com/office/drawing/2014/main" val="1491587572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369175592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930756427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294532412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605158839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476090549"/>
                    </a:ext>
                  </a:extLst>
                </a:gridCol>
              </a:tblGrid>
              <a:tr h="281146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estrin2 shRNA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ontrol shRNA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60946664"/>
                  </a:ext>
                </a:extLst>
              </a:tr>
              <a:tr h="281146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83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.04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.14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.1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.10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2.34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8969901"/>
                  </a:ext>
                </a:extLst>
              </a:tr>
              <a:tr h="281146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5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8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51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79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83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93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2185427"/>
                  </a:ext>
                </a:extLst>
              </a:tr>
              <a:tr h="281146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75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94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.15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.08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.11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.24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89909155"/>
                  </a:ext>
                </a:extLst>
              </a:tr>
              <a:tr h="281146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74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84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74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2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26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1.33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5536181"/>
                  </a:ext>
                </a:extLst>
              </a:tr>
            </a:tbl>
          </a:graphicData>
        </a:graphic>
      </p:graphicFrame>
      <p:sp>
        <p:nvSpPr>
          <p:cNvPr id="7" name="图形 7">
            <a:extLst>
              <a:ext uri="{FF2B5EF4-FFF2-40B4-BE49-F238E27FC236}">
                <a16:creationId xmlns:a16="http://schemas.microsoft.com/office/drawing/2014/main" id="{703F902B-B48B-4CDE-AD56-3A1887BC53E7}"/>
              </a:ext>
            </a:extLst>
          </p:cNvPr>
          <p:cNvSpPr txBox="1"/>
          <p:nvPr/>
        </p:nvSpPr>
        <p:spPr>
          <a:xfrm>
            <a:off x="4882264" y="3351434"/>
            <a:ext cx="275911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797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8" name="图形 7">
            <a:extLst>
              <a:ext uri="{FF2B5EF4-FFF2-40B4-BE49-F238E27FC236}">
                <a16:creationId xmlns:a16="http://schemas.microsoft.com/office/drawing/2014/main" id="{85C82455-BA71-4684-B870-D26BCA309F68}"/>
              </a:ext>
            </a:extLst>
          </p:cNvPr>
          <p:cNvSpPr txBox="1"/>
          <p:nvPr/>
        </p:nvSpPr>
        <p:spPr>
          <a:xfrm>
            <a:off x="4884476" y="3530822"/>
            <a:ext cx="275911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797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9" name="图形 7">
            <a:extLst>
              <a:ext uri="{FF2B5EF4-FFF2-40B4-BE49-F238E27FC236}">
                <a16:creationId xmlns:a16="http://schemas.microsoft.com/office/drawing/2014/main" id="{672B9909-F0F6-4FF2-B3F7-5CF6A2FEF5FD}"/>
              </a:ext>
            </a:extLst>
          </p:cNvPr>
          <p:cNvSpPr txBox="1"/>
          <p:nvPr/>
        </p:nvSpPr>
        <p:spPr>
          <a:xfrm>
            <a:off x="5480932" y="3351434"/>
            <a:ext cx="342362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797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  <p:sp>
        <p:nvSpPr>
          <p:cNvPr id="10" name="图形 7">
            <a:extLst>
              <a:ext uri="{FF2B5EF4-FFF2-40B4-BE49-F238E27FC236}">
                <a16:creationId xmlns:a16="http://schemas.microsoft.com/office/drawing/2014/main" id="{77E3A360-29CE-4907-B913-B6DE7261F8DF}"/>
              </a:ext>
            </a:extLst>
          </p:cNvPr>
          <p:cNvSpPr txBox="1"/>
          <p:nvPr/>
        </p:nvSpPr>
        <p:spPr>
          <a:xfrm>
            <a:off x="6137557" y="3541986"/>
            <a:ext cx="342362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797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  <p:sp>
        <p:nvSpPr>
          <p:cNvPr id="11" name="图形 7">
            <a:extLst>
              <a:ext uri="{FF2B5EF4-FFF2-40B4-BE49-F238E27FC236}">
                <a16:creationId xmlns:a16="http://schemas.microsoft.com/office/drawing/2014/main" id="{0D6C3608-FBCB-4A14-903F-0F4A10DAB738}"/>
              </a:ext>
            </a:extLst>
          </p:cNvPr>
          <p:cNvSpPr txBox="1"/>
          <p:nvPr/>
        </p:nvSpPr>
        <p:spPr>
          <a:xfrm>
            <a:off x="6800097" y="3324508"/>
            <a:ext cx="342362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797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  <p:sp>
        <p:nvSpPr>
          <p:cNvPr id="12" name="图形 7">
            <a:extLst>
              <a:ext uri="{FF2B5EF4-FFF2-40B4-BE49-F238E27FC236}">
                <a16:creationId xmlns:a16="http://schemas.microsoft.com/office/drawing/2014/main" id="{4A466862-A00F-4F88-A87D-3839C4EB7E41}"/>
              </a:ext>
            </a:extLst>
          </p:cNvPr>
          <p:cNvSpPr txBox="1"/>
          <p:nvPr/>
        </p:nvSpPr>
        <p:spPr>
          <a:xfrm>
            <a:off x="5513221" y="3530821"/>
            <a:ext cx="275911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797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13" name="图形 7">
            <a:extLst>
              <a:ext uri="{FF2B5EF4-FFF2-40B4-BE49-F238E27FC236}">
                <a16:creationId xmlns:a16="http://schemas.microsoft.com/office/drawing/2014/main" id="{9C02F97D-2B29-4545-9975-3DC352EDE0C3}"/>
              </a:ext>
            </a:extLst>
          </p:cNvPr>
          <p:cNvSpPr txBox="1"/>
          <p:nvPr/>
        </p:nvSpPr>
        <p:spPr>
          <a:xfrm>
            <a:off x="6163922" y="3324507"/>
            <a:ext cx="275911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797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14" name="图形 7">
            <a:extLst>
              <a:ext uri="{FF2B5EF4-FFF2-40B4-BE49-F238E27FC236}">
                <a16:creationId xmlns:a16="http://schemas.microsoft.com/office/drawing/2014/main" id="{EB760E72-A62F-4FF6-8849-B361018FFAB0}"/>
              </a:ext>
            </a:extLst>
          </p:cNvPr>
          <p:cNvSpPr txBox="1"/>
          <p:nvPr/>
        </p:nvSpPr>
        <p:spPr>
          <a:xfrm>
            <a:off x="6797877" y="3520830"/>
            <a:ext cx="342362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797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  <p:sp>
        <p:nvSpPr>
          <p:cNvPr id="15" name="图形 7">
            <a:extLst>
              <a:ext uri="{FF2B5EF4-FFF2-40B4-BE49-F238E27FC236}">
                <a16:creationId xmlns:a16="http://schemas.microsoft.com/office/drawing/2014/main" id="{DFC270E1-BFB5-4B95-A9BA-B64C61F50749}"/>
              </a:ext>
            </a:extLst>
          </p:cNvPr>
          <p:cNvSpPr txBox="1"/>
          <p:nvPr/>
        </p:nvSpPr>
        <p:spPr>
          <a:xfrm>
            <a:off x="3980494" y="3351430"/>
            <a:ext cx="44958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Cis</a:t>
            </a:r>
          </a:p>
        </p:txBody>
      </p:sp>
      <p:sp>
        <p:nvSpPr>
          <p:cNvPr id="16" name="图形 7">
            <a:extLst>
              <a:ext uri="{FF2B5EF4-FFF2-40B4-BE49-F238E27FC236}">
                <a16:creationId xmlns:a16="http://schemas.microsoft.com/office/drawing/2014/main" id="{3C3B149B-A3C2-4379-A1F5-0BC36B2DC6D4}"/>
              </a:ext>
            </a:extLst>
          </p:cNvPr>
          <p:cNvSpPr txBox="1"/>
          <p:nvPr/>
        </p:nvSpPr>
        <p:spPr>
          <a:xfrm>
            <a:off x="3980494" y="3573681"/>
            <a:ext cx="52578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Rap</a:t>
            </a:r>
          </a:p>
        </p:txBody>
      </p:sp>
    </p:spTree>
    <p:extLst>
      <p:ext uri="{BB962C8B-B14F-4D97-AF65-F5344CB8AC3E}">
        <p14:creationId xmlns:p14="http://schemas.microsoft.com/office/powerpoint/2010/main" val="428903800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5981E30-44F0-4A4A-8441-36555543AD6C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4D</a:t>
            </a:r>
            <a:endParaRPr lang="zh-CN" altLang="en-US" dirty="0"/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7E34CFE4-E1D8-4734-BADA-B57C579905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70325" y="426005"/>
            <a:ext cx="3384550" cy="2533650"/>
          </a:xfrm>
          <a:prstGeom prst="rect">
            <a:avLst/>
          </a:prstGeom>
        </p:spPr>
      </p:pic>
      <p:sp>
        <p:nvSpPr>
          <p:cNvPr id="35" name="图形 33">
            <a:extLst>
              <a:ext uri="{FF2B5EF4-FFF2-40B4-BE49-F238E27FC236}">
                <a16:creationId xmlns:a16="http://schemas.microsoft.com/office/drawing/2014/main" id="{938070E2-3B45-4629-8B57-1BC6D92B099B}"/>
              </a:ext>
            </a:extLst>
          </p:cNvPr>
          <p:cNvSpPr txBox="1"/>
          <p:nvPr/>
        </p:nvSpPr>
        <p:spPr>
          <a:xfrm>
            <a:off x="3377774" y="2787404"/>
            <a:ext cx="50673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Dox</a:t>
            </a:r>
          </a:p>
        </p:txBody>
      </p:sp>
      <p:sp>
        <p:nvSpPr>
          <p:cNvPr id="36" name="图形 33">
            <a:extLst>
              <a:ext uri="{FF2B5EF4-FFF2-40B4-BE49-F238E27FC236}">
                <a16:creationId xmlns:a16="http://schemas.microsoft.com/office/drawing/2014/main" id="{938070E2-3B45-4629-8B57-1BC6D92B099B}"/>
              </a:ext>
            </a:extLst>
          </p:cNvPr>
          <p:cNvSpPr txBox="1"/>
          <p:nvPr/>
        </p:nvSpPr>
        <p:spPr>
          <a:xfrm>
            <a:off x="3377779" y="3006479"/>
            <a:ext cx="64008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3-MA</a:t>
            </a:r>
          </a:p>
        </p:txBody>
      </p:sp>
      <p:sp>
        <p:nvSpPr>
          <p:cNvPr id="37" name="图形 33">
            <a:extLst>
              <a:ext uri="{FF2B5EF4-FFF2-40B4-BE49-F238E27FC236}">
                <a16:creationId xmlns:a16="http://schemas.microsoft.com/office/drawing/2014/main" id="{938070E2-3B45-4629-8B57-1BC6D92B099B}"/>
              </a:ext>
            </a:extLst>
          </p:cNvPr>
          <p:cNvSpPr txBox="1"/>
          <p:nvPr/>
        </p:nvSpPr>
        <p:spPr>
          <a:xfrm>
            <a:off x="4706511" y="2793752"/>
            <a:ext cx="249555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38" name="图形 33">
            <a:extLst>
              <a:ext uri="{FF2B5EF4-FFF2-40B4-BE49-F238E27FC236}">
                <a16:creationId xmlns:a16="http://schemas.microsoft.com/office/drawing/2014/main" id="{938070E2-3B45-4629-8B57-1BC6D92B099B}"/>
              </a:ext>
            </a:extLst>
          </p:cNvPr>
          <p:cNvSpPr txBox="1"/>
          <p:nvPr/>
        </p:nvSpPr>
        <p:spPr>
          <a:xfrm>
            <a:off x="4706510" y="2987427"/>
            <a:ext cx="249555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39" name="图形 33">
            <a:extLst>
              <a:ext uri="{FF2B5EF4-FFF2-40B4-BE49-F238E27FC236}">
                <a16:creationId xmlns:a16="http://schemas.microsoft.com/office/drawing/2014/main" id="{938070E2-3B45-4629-8B57-1BC6D92B099B}"/>
              </a:ext>
            </a:extLst>
          </p:cNvPr>
          <p:cNvSpPr txBox="1"/>
          <p:nvPr/>
        </p:nvSpPr>
        <p:spPr>
          <a:xfrm>
            <a:off x="5341124" y="2987425"/>
            <a:ext cx="249555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40" name="图形 33">
            <a:extLst>
              <a:ext uri="{FF2B5EF4-FFF2-40B4-BE49-F238E27FC236}">
                <a16:creationId xmlns:a16="http://schemas.microsoft.com/office/drawing/2014/main" id="{938070E2-3B45-4629-8B57-1BC6D92B099B}"/>
              </a:ext>
            </a:extLst>
          </p:cNvPr>
          <p:cNvSpPr txBox="1"/>
          <p:nvPr/>
        </p:nvSpPr>
        <p:spPr>
          <a:xfrm>
            <a:off x="5986355" y="2793750"/>
            <a:ext cx="249555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41" name="图形 33">
            <a:extLst>
              <a:ext uri="{FF2B5EF4-FFF2-40B4-BE49-F238E27FC236}">
                <a16:creationId xmlns:a16="http://schemas.microsoft.com/office/drawing/2014/main" id="{938070E2-3B45-4629-8B57-1BC6D92B099B}"/>
              </a:ext>
            </a:extLst>
          </p:cNvPr>
          <p:cNvSpPr txBox="1"/>
          <p:nvPr/>
        </p:nvSpPr>
        <p:spPr>
          <a:xfrm>
            <a:off x="5322074" y="2793750"/>
            <a:ext cx="29718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  <p:sp>
        <p:nvSpPr>
          <p:cNvPr id="42" name="图形 33">
            <a:extLst>
              <a:ext uri="{FF2B5EF4-FFF2-40B4-BE49-F238E27FC236}">
                <a16:creationId xmlns:a16="http://schemas.microsoft.com/office/drawing/2014/main" id="{938070E2-3B45-4629-8B57-1BC6D92B099B}"/>
              </a:ext>
            </a:extLst>
          </p:cNvPr>
          <p:cNvSpPr txBox="1"/>
          <p:nvPr/>
        </p:nvSpPr>
        <p:spPr>
          <a:xfrm>
            <a:off x="6609746" y="2793752"/>
            <a:ext cx="29718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  <p:sp>
        <p:nvSpPr>
          <p:cNvPr id="43" name="图形 33">
            <a:extLst>
              <a:ext uri="{FF2B5EF4-FFF2-40B4-BE49-F238E27FC236}">
                <a16:creationId xmlns:a16="http://schemas.microsoft.com/office/drawing/2014/main" id="{938070E2-3B45-4629-8B57-1BC6D92B099B}"/>
              </a:ext>
            </a:extLst>
          </p:cNvPr>
          <p:cNvSpPr txBox="1"/>
          <p:nvPr/>
        </p:nvSpPr>
        <p:spPr>
          <a:xfrm>
            <a:off x="5967305" y="2987430"/>
            <a:ext cx="29718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  <p:sp>
        <p:nvSpPr>
          <p:cNvPr id="44" name="图形 33">
            <a:extLst>
              <a:ext uri="{FF2B5EF4-FFF2-40B4-BE49-F238E27FC236}">
                <a16:creationId xmlns:a16="http://schemas.microsoft.com/office/drawing/2014/main" id="{938070E2-3B45-4629-8B57-1BC6D92B099B}"/>
              </a:ext>
            </a:extLst>
          </p:cNvPr>
          <p:cNvSpPr txBox="1"/>
          <p:nvPr/>
        </p:nvSpPr>
        <p:spPr>
          <a:xfrm>
            <a:off x="6609746" y="2987422"/>
            <a:ext cx="29718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  <p:graphicFrame>
        <p:nvGraphicFramePr>
          <p:cNvPr id="45" name="表格 44">
            <a:extLst>
              <a:ext uri="{FF2B5EF4-FFF2-40B4-BE49-F238E27FC236}">
                <a16:creationId xmlns:a16="http://schemas.microsoft.com/office/drawing/2014/main" id="{B6D9B3FF-F73F-4C8A-90A2-E868B103C7E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5012604"/>
              </p:ext>
            </p:extLst>
          </p:nvPr>
        </p:nvGraphicFramePr>
        <p:xfrm>
          <a:off x="2667000" y="3604419"/>
          <a:ext cx="6858000" cy="1568715"/>
        </p:xfrm>
        <a:graphic>
          <a:graphicData uri="http://schemas.openxmlformats.org/drawingml/2006/table">
            <a:tbl>
              <a:tblPr/>
              <a:tblGrid>
                <a:gridCol w="1143000">
                  <a:extLst>
                    <a:ext uri="{9D8B030D-6E8A-4147-A177-3AD203B41FA5}">
                      <a16:colId xmlns:a16="http://schemas.microsoft.com/office/drawing/2014/main" val="2926918948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849297761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402236487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873536616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389888671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589472828"/>
                    </a:ext>
                  </a:extLst>
                </a:gridCol>
              </a:tblGrid>
              <a:tr h="313743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HBLV contro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HBLV sestrin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65866468"/>
                  </a:ext>
                </a:extLst>
              </a:tr>
              <a:tr h="313743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.0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.16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.02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.1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.25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.01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5755276"/>
                  </a:ext>
                </a:extLst>
              </a:tr>
              <a:tr h="313743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64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72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69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36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52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49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2519771"/>
                  </a:ext>
                </a:extLst>
              </a:tr>
              <a:tr h="313743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.42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.62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.14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.79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.65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.34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5244700"/>
                  </a:ext>
                </a:extLst>
              </a:tr>
              <a:tr h="313743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63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61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62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71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73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69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109867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583874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76EE6B4-FAF4-45AD-8965-1C8C1CC7A911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2C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E865FEC0-8C42-4AA7-9D82-332B3E734309}"/>
              </a:ext>
            </a:extLst>
          </p:cNvPr>
          <p:cNvSpPr txBox="1"/>
          <p:nvPr/>
        </p:nvSpPr>
        <p:spPr>
          <a:xfrm>
            <a:off x="5347236" y="241339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ox</a:t>
            </a:r>
            <a:endParaRPr lang="zh-CN" altLang="en-US" dirty="0"/>
          </a:p>
        </p:txBody>
      </p:sp>
      <p:graphicFrame>
        <p:nvGraphicFramePr>
          <p:cNvPr id="8" name="表格 7">
            <a:extLst>
              <a:ext uri="{FF2B5EF4-FFF2-40B4-BE49-F238E27FC236}">
                <a16:creationId xmlns:a16="http://schemas.microsoft.com/office/drawing/2014/main" id="{F7924D78-D9BD-4A88-9D68-F636809E65D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6825935"/>
              </p:ext>
            </p:extLst>
          </p:nvPr>
        </p:nvGraphicFramePr>
        <p:xfrm>
          <a:off x="1165761" y="3275605"/>
          <a:ext cx="8534400" cy="1977230"/>
        </p:xfrm>
        <a:graphic>
          <a:graphicData uri="http://schemas.openxmlformats.org/drawingml/2006/table">
            <a:tbl>
              <a:tblPr/>
              <a:tblGrid>
                <a:gridCol w="533400">
                  <a:extLst>
                    <a:ext uri="{9D8B030D-6E8A-4147-A177-3AD203B41FA5}">
                      <a16:colId xmlns:a16="http://schemas.microsoft.com/office/drawing/2014/main" val="3197958899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690408168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203125958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411620493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467589735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915418182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504685728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49169740"/>
                    </a:ext>
                  </a:extLst>
                </a:gridCol>
              </a:tblGrid>
              <a:tr h="395446"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ontrol shRNA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estrin2 shRNA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76477801"/>
                  </a:ext>
                </a:extLst>
              </a:tr>
              <a:tr h="395446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2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4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3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5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2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4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6798886"/>
                  </a:ext>
                </a:extLst>
              </a:tr>
              <a:tr h="395446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7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7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7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5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7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6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0005884"/>
                  </a:ext>
                </a:extLst>
              </a:tr>
              <a:tr h="395446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59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68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64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2240716"/>
                  </a:ext>
                </a:extLst>
              </a:tr>
              <a:tr h="395446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01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03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02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6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8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9268963"/>
                  </a:ext>
                </a:extLst>
              </a:tr>
            </a:tbl>
          </a:graphicData>
        </a:graphic>
      </p:graphicFrame>
      <p:pic>
        <p:nvPicPr>
          <p:cNvPr id="9" name="图片 8">
            <a:extLst>
              <a:ext uri="{FF2B5EF4-FFF2-40B4-BE49-F238E27FC236}">
                <a16:creationId xmlns:a16="http://schemas.microsoft.com/office/drawing/2014/main" id="{7AB0FC2A-C175-4F26-9908-3AC77A2BA8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49700" y="805455"/>
            <a:ext cx="3511550" cy="247015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1AF52310-3F57-4DB4-A7CD-DA7AC4EB4067}"/>
              </a:ext>
            </a:extLst>
          </p:cNvPr>
          <p:cNvSpPr txBox="1"/>
          <p:nvPr/>
        </p:nvSpPr>
        <p:spPr>
          <a:xfrm>
            <a:off x="5071011" y="5818226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G-6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471629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76EE6B4-FAF4-45AD-8965-1C8C1CC7A911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2C</a:t>
            </a: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E61722EB-BFC8-4D60-93A7-5F4AE972F3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44925" y="850900"/>
            <a:ext cx="3511550" cy="2470150"/>
          </a:xfrm>
          <a:prstGeom prst="rect">
            <a:avLst/>
          </a:prstGeom>
        </p:spPr>
      </p:pic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D8D5CA7F-75B8-4D96-8389-1671D271317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8343088"/>
              </p:ext>
            </p:extLst>
          </p:nvPr>
        </p:nvGraphicFramePr>
        <p:xfrm>
          <a:off x="1266825" y="3671094"/>
          <a:ext cx="8534400" cy="2082005"/>
        </p:xfrm>
        <a:graphic>
          <a:graphicData uri="http://schemas.openxmlformats.org/drawingml/2006/table">
            <a:tbl>
              <a:tblPr/>
              <a:tblGrid>
                <a:gridCol w="533400">
                  <a:extLst>
                    <a:ext uri="{9D8B030D-6E8A-4147-A177-3AD203B41FA5}">
                      <a16:colId xmlns:a16="http://schemas.microsoft.com/office/drawing/2014/main" val="2775182629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278529196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871098186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66603587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928670939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4255100007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4021094313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84432531"/>
                    </a:ext>
                  </a:extLst>
                </a:gridCol>
              </a:tblGrid>
              <a:tr h="416401"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ontrol shRNA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estrin2 shRNA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6352534"/>
                  </a:ext>
                </a:extLst>
              </a:tr>
              <a:tr h="41640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4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3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4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2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3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5560023"/>
                  </a:ext>
                </a:extLst>
              </a:tr>
              <a:tr h="41640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5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8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6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2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8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5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4997517"/>
                  </a:ext>
                </a:extLst>
              </a:tr>
              <a:tr h="41640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72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81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77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8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52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50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7830383"/>
                  </a:ext>
                </a:extLst>
              </a:tr>
              <a:tr h="41640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1.01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15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1.08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8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54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50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7415216"/>
                  </a:ext>
                </a:extLst>
              </a:tr>
            </a:tbl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3DA71945-8881-40EA-A4A5-2B56DCEAE960}"/>
              </a:ext>
            </a:extLst>
          </p:cNvPr>
          <p:cNvSpPr txBox="1"/>
          <p:nvPr/>
        </p:nvSpPr>
        <p:spPr>
          <a:xfrm>
            <a:off x="5071011" y="5818226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G-63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670D2641-2FA5-40F2-835F-792F8670B680}"/>
              </a:ext>
            </a:extLst>
          </p:cNvPr>
          <p:cNvSpPr txBox="1"/>
          <p:nvPr/>
        </p:nvSpPr>
        <p:spPr>
          <a:xfrm>
            <a:off x="5347236" y="241339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Mtx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302505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76EE6B4-FAF4-45AD-8965-1C8C1CC7A911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2C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E28F057-4530-4E00-ACCC-82FDB0D9E0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87800" y="612775"/>
            <a:ext cx="3511550" cy="2470150"/>
          </a:xfrm>
          <a:prstGeom prst="rect">
            <a:avLst/>
          </a:prstGeom>
        </p:spPr>
      </p:pic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0999F000-13E0-48FC-8CD7-0BD4B6F2C2C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0706539"/>
              </p:ext>
            </p:extLst>
          </p:nvPr>
        </p:nvGraphicFramePr>
        <p:xfrm>
          <a:off x="1828800" y="3604417"/>
          <a:ext cx="8534400" cy="1948655"/>
        </p:xfrm>
        <a:graphic>
          <a:graphicData uri="http://schemas.openxmlformats.org/drawingml/2006/table">
            <a:tbl>
              <a:tblPr/>
              <a:tblGrid>
                <a:gridCol w="533400">
                  <a:extLst>
                    <a:ext uri="{9D8B030D-6E8A-4147-A177-3AD203B41FA5}">
                      <a16:colId xmlns:a16="http://schemas.microsoft.com/office/drawing/2014/main" val="3171917119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965213562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372336513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080205032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169990118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453332238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058766142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296859434"/>
                    </a:ext>
                  </a:extLst>
                </a:gridCol>
              </a:tblGrid>
              <a:tr h="389731"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ontrol shRNA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estrin2 shRNA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2046273"/>
                  </a:ext>
                </a:extLst>
              </a:tr>
              <a:tr h="38973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2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3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2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3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3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3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3675817"/>
                  </a:ext>
                </a:extLst>
              </a:tr>
              <a:tr h="38973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9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53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51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6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5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5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5764770"/>
                  </a:ext>
                </a:extLst>
              </a:tr>
              <a:tr h="38973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63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79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71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54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7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51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5598536"/>
                  </a:ext>
                </a:extLst>
              </a:tr>
              <a:tr h="38973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94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1.23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1.08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75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73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74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4980434"/>
                  </a:ext>
                </a:extLst>
              </a:tr>
            </a:tbl>
          </a:graphicData>
        </a:graphic>
      </p:graphicFrame>
      <p:sp>
        <p:nvSpPr>
          <p:cNvPr id="6" name="文本框 5">
            <a:extLst>
              <a:ext uri="{FF2B5EF4-FFF2-40B4-BE49-F238E27FC236}">
                <a16:creationId xmlns:a16="http://schemas.microsoft.com/office/drawing/2014/main" id="{44DD9C32-7D37-46D1-AD07-B0794526418A}"/>
              </a:ext>
            </a:extLst>
          </p:cNvPr>
          <p:cNvSpPr txBox="1"/>
          <p:nvPr/>
        </p:nvSpPr>
        <p:spPr>
          <a:xfrm>
            <a:off x="5071011" y="5818226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OS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20CBF63-C134-4206-9C8F-247E98934465}"/>
              </a:ext>
            </a:extLst>
          </p:cNvPr>
          <p:cNvSpPr txBox="1"/>
          <p:nvPr/>
        </p:nvSpPr>
        <p:spPr>
          <a:xfrm>
            <a:off x="5347236" y="241339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i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227215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76EE6B4-FAF4-45AD-8965-1C8C1CC7A911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2C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54CCFB5-8342-4D75-A274-5BBB9A7EEE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16400" y="831850"/>
            <a:ext cx="3511550" cy="247015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F138C9A-F64A-4348-B69F-CBAC4A655369}"/>
              </a:ext>
            </a:extLst>
          </p:cNvPr>
          <p:cNvSpPr txBox="1"/>
          <p:nvPr/>
        </p:nvSpPr>
        <p:spPr>
          <a:xfrm>
            <a:off x="5071011" y="5818226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OS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1D5860C6-8854-4DA0-A88F-60B73B85A9DF}"/>
              </a:ext>
            </a:extLst>
          </p:cNvPr>
          <p:cNvSpPr txBox="1"/>
          <p:nvPr/>
        </p:nvSpPr>
        <p:spPr>
          <a:xfrm>
            <a:off x="5347236" y="241339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ox</a:t>
            </a:r>
            <a:endParaRPr lang="zh-CN" altLang="en-US" dirty="0"/>
          </a:p>
        </p:txBody>
      </p:sp>
      <p:graphicFrame>
        <p:nvGraphicFramePr>
          <p:cNvPr id="7" name="表格 6">
            <a:extLst>
              <a:ext uri="{FF2B5EF4-FFF2-40B4-BE49-F238E27FC236}">
                <a16:creationId xmlns:a16="http://schemas.microsoft.com/office/drawing/2014/main" id="{494E6A29-48C4-4B39-A3ED-5D3011311E1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5304015"/>
              </p:ext>
            </p:extLst>
          </p:nvPr>
        </p:nvGraphicFramePr>
        <p:xfrm>
          <a:off x="1828800" y="3604420"/>
          <a:ext cx="8534400" cy="1720055"/>
        </p:xfrm>
        <a:graphic>
          <a:graphicData uri="http://schemas.openxmlformats.org/drawingml/2006/table">
            <a:tbl>
              <a:tblPr/>
              <a:tblGrid>
                <a:gridCol w="533400">
                  <a:extLst>
                    <a:ext uri="{9D8B030D-6E8A-4147-A177-3AD203B41FA5}">
                      <a16:colId xmlns:a16="http://schemas.microsoft.com/office/drawing/2014/main" val="2426514768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616255446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474875962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336274360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467962899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288102297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600529536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4195791645"/>
                    </a:ext>
                  </a:extLst>
                </a:gridCol>
              </a:tblGrid>
              <a:tr h="344011"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ontrol shRNA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estrin2 shRNA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96190621"/>
                  </a:ext>
                </a:extLst>
              </a:tr>
              <a:tr h="34401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4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9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7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6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9374100"/>
                  </a:ext>
                </a:extLst>
              </a:tr>
              <a:tr h="34401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8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8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7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5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8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7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5153162"/>
                  </a:ext>
                </a:extLst>
              </a:tr>
              <a:tr h="34401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82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85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84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6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6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6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0614796"/>
                  </a:ext>
                </a:extLst>
              </a:tr>
              <a:tr h="34401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1.08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1.18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1.13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50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8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9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195367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42092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76EE6B4-FAF4-45AD-8965-1C8C1CC7A911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2C</a:t>
            </a:r>
            <a:endParaRPr lang="zh-CN" altLang="en-US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767FFBAA-F65D-4289-B9B2-02922B171001}"/>
              </a:ext>
            </a:extLst>
          </p:cNvPr>
          <p:cNvSpPr txBox="1"/>
          <p:nvPr/>
        </p:nvSpPr>
        <p:spPr>
          <a:xfrm>
            <a:off x="5071011" y="5818226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OS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4D54084B-8BBD-430D-B2EE-65D526B09C43}"/>
              </a:ext>
            </a:extLst>
          </p:cNvPr>
          <p:cNvSpPr txBox="1"/>
          <p:nvPr/>
        </p:nvSpPr>
        <p:spPr>
          <a:xfrm>
            <a:off x="5347236" y="241339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Mtx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D316B44F-B2D5-41BA-A162-D74C56EA5C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78275" y="744298"/>
            <a:ext cx="3511550" cy="2470150"/>
          </a:xfrm>
          <a:prstGeom prst="rect">
            <a:avLst/>
          </a:prstGeom>
        </p:spPr>
      </p:pic>
      <p:graphicFrame>
        <p:nvGraphicFramePr>
          <p:cNvPr id="7" name="表格 6">
            <a:extLst>
              <a:ext uri="{FF2B5EF4-FFF2-40B4-BE49-F238E27FC236}">
                <a16:creationId xmlns:a16="http://schemas.microsoft.com/office/drawing/2014/main" id="{34B148E1-0643-4E6F-A2F8-C9A9FDA23B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31577187"/>
              </p:ext>
            </p:extLst>
          </p:nvPr>
        </p:nvGraphicFramePr>
        <p:xfrm>
          <a:off x="1495425" y="3643553"/>
          <a:ext cx="8534400" cy="1586705"/>
        </p:xfrm>
        <a:graphic>
          <a:graphicData uri="http://schemas.openxmlformats.org/drawingml/2006/table">
            <a:tbl>
              <a:tblPr/>
              <a:tblGrid>
                <a:gridCol w="533400">
                  <a:extLst>
                    <a:ext uri="{9D8B030D-6E8A-4147-A177-3AD203B41FA5}">
                      <a16:colId xmlns:a16="http://schemas.microsoft.com/office/drawing/2014/main" val="461615787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458475274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4260212835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240805549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951711278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569234889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560507607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75241017"/>
                    </a:ext>
                  </a:extLst>
                </a:gridCol>
              </a:tblGrid>
              <a:tr h="317341"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ontrol shRNA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estrin2 shRNA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40920983"/>
                  </a:ext>
                </a:extLst>
              </a:tr>
              <a:tr h="31734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4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3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3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1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2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4909325"/>
                  </a:ext>
                </a:extLst>
              </a:tr>
              <a:tr h="31734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8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54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51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7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9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8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4755727"/>
                  </a:ext>
                </a:extLst>
              </a:tr>
              <a:tr h="31734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63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79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71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7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9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8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0076661"/>
                  </a:ext>
                </a:extLst>
              </a:tr>
              <a:tr h="31734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97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1.05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1.02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59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68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63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925124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559212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76EE6B4-FAF4-45AD-8965-1C8C1CC7A911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2H</a:t>
            </a: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116092F4-59F9-4A8D-BD49-4458A1D032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62923" y="540305"/>
            <a:ext cx="3511550" cy="247015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48A33BDD-9799-43A4-B839-A8A76DE2635D}"/>
              </a:ext>
            </a:extLst>
          </p:cNvPr>
          <p:cNvSpPr txBox="1"/>
          <p:nvPr/>
        </p:nvSpPr>
        <p:spPr>
          <a:xfrm>
            <a:off x="5394861" y="241339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is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9BE5D80-1FFC-468D-B473-00A761E7AD01}"/>
              </a:ext>
            </a:extLst>
          </p:cNvPr>
          <p:cNvSpPr txBox="1"/>
          <p:nvPr/>
        </p:nvSpPr>
        <p:spPr>
          <a:xfrm>
            <a:off x="5071011" y="5818226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G-63</a:t>
            </a:r>
            <a:endParaRPr lang="zh-CN" altLang="en-US" dirty="0"/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F55A0EBE-4738-496A-AF48-30B2BBC917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8420077"/>
              </p:ext>
            </p:extLst>
          </p:nvPr>
        </p:nvGraphicFramePr>
        <p:xfrm>
          <a:off x="1495425" y="3309421"/>
          <a:ext cx="8534400" cy="1815305"/>
        </p:xfrm>
        <a:graphic>
          <a:graphicData uri="http://schemas.openxmlformats.org/drawingml/2006/table">
            <a:tbl>
              <a:tblPr/>
              <a:tblGrid>
                <a:gridCol w="533400">
                  <a:extLst>
                    <a:ext uri="{9D8B030D-6E8A-4147-A177-3AD203B41FA5}">
                      <a16:colId xmlns:a16="http://schemas.microsoft.com/office/drawing/2014/main" val="4053610260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337011001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4261191982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055679939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075343345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4133980723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202978403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080207745"/>
                    </a:ext>
                  </a:extLst>
                </a:gridCol>
              </a:tblGrid>
              <a:tr h="363061"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HBLV sestrin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HBLV contro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27709808"/>
                  </a:ext>
                </a:extLst>
              </a:tr>
              <a:tr h="36306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17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5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1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18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2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21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1389440"/>
                  </a:ext>
                </a:extLst>
              </a:tr>
              <a:tr h="36306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6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8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5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6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5384458"/>
                  </a:ext>
                </a:extLst>
              </a:tr>
              <a:tr h="36306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71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6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67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0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9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0477566"/>
                  </a:ext>
                </a:extLst>
              </a:tr>
              <a:tr h="36306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25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87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06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4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4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481877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1121242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76EE6B4-FAF4-45AD-8965-1C8C1CC7A911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2H</a:t>
            </a: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9EB3EC45-AB06-4818-B88B-4DD9B75BC5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78275" y="610671"/>
            <a:ext cx="3511550" cy="247015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EC5FA795-10FB-496B-BA4E-3A95BBCBA245}"/>
              </a:ext>
            </a:extLst>
          </p:cNvPr>
          <p:cNvSpPr txBox="1"/>
          <p:nvPr/>
        </p:nvSpPr>
        <p:spPr>
          <a:xfrm>
            <a:off x="5347236" y="241339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ox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87C34BE4-4458-4587-877A-37C12A6B58D3}"/>
              </a:ext>
            </a:extLst>
          </p:cNvPr>
          <p:cNvSpPr txBox="1"/>
          <p:nvPr/>
        </p:nvSpPr>
        <p:spPr>
          <a:xfrm>
            <a:off x="5071011" y="5818226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G-63</a:t>
            </a:r>
            <a:endParaRPr lang="zh-CN" altLang="en-US" dirty="0"/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1013F561-EB79-44C2-95DE-501EE2F3A0A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8892039"/>
              </p:ext>
            </p:extLst>
          </p:nvPr>
        </p:nvGraphicFramePr>
        <p:xfrm>
          <a:off x="1828800" y="3604419"/>
          <a:ext cx="8534400" cy="1548605"/>
        </p:xfrm>
        <a:graphic>
          <a:graphicData uri="http://schemas.openxmlformats.org/drawingml/2006/table">
            <a:tbl>
              <a:tblPr/>
              <a:tblGrid>
                <a:gridCol w="533400">
                  <a:extLst>
                    <a:ext uri="{9D8B030D-6E8A-4147-A177-3AD203B41FA5}">
                      <a16:colId xmlns:a16="http://schemas.microsoft.com/office/drawing/2014/main" val="3219061604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144163868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028287495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095039269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597526555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4208007343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76705506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517387005"/>
                    </a:ext>
                  </a:extLst>
                </a:gridCol>
              </a:tblGrid>
              <a:tr h="309721"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HBLV sestrin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HBLV contro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9198696"/>
                  </a:ext>
                </a:extLst>
              </a:tr>
              <a:tr h="30972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19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8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4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18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19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19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0652990"/>
                  </a:ext>
                </a:extLst>
              </a:tr>
              <a:tr h="30972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7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8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8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9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8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9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2781419"/>
                  </a:ext>
                </a:extLst>
              </a:tr>
              <a:tr h="30972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8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89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85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3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0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2438085"/>
                  </a:ext>
                </a:extLst>
              </a:tr>
              <a:tr h="30972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29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17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23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5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6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9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886842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4243990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76EE6B4-FAF4-45AD-8965-1C8C1CC7A911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2H</a:t>
            </a: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82524D0F-43F3-4E7F-BBCA-92F457812A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68750" y="610671"/>
            <a:ext cx="3511550" cy="247015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E99FF161-A495-4341-AE41-F14AF9DE0125}"/>
              </a:ext>
            </a:extLst>
          </p:cNvPr>
          <p:cNvSpPr txBox="1"/>
          <p:nvPr/>
        </p:nvSpPr>
        <p:spPr>
          <a:xfrm>
            <a:off x="5071011" y="5818226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G-63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730175A1-6B7E-4E17-9EEA-6DCFFEF1EB58}"/>
              </a:ext>
            </a:extLst>
          </p:cNvPr>
          <p:cNvSpPr txBox="1"/>
          <p:nvPr/>
        </p:nvSpPr>
        <p:spPr>
          <a:xfrm>
            <a:off x="5347236" y="241339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Mtx</a:t>
            </a:r>
            <a:endParaRPr lang="zh-CN" altLang="en-US" dirty="0"/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ADA08CB0-F9D7-47E9-A37F-DB337F66A3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343595"/>
              </p:ext>
            </p:extLst>
          </p:nvPr>
        </p:nvGraphicFramePr>
        <p:xfrm>
          <a:off x="1828800" y="3604418"/>
          <a:ext cx="8534400" cy="1881980"/>
        </p:xfrm>
        <a:graphic>
          <a:graphicData uri="http://schemas.openxmlformats.org/drawingml/2006/table">
            <a:tbl>
              <a:tblPr/>
              <a:tblGrid>
                <a:gridCol w="533400">
                  <a:extLst>
                    <a:ext uri="{9D8B030D-6E8A-4147-A177-3AD203B41FA5}">
                      <a16:colId xmlns:a16="http://schemas.microsoft.com/office/drawing/2014/main" val="3973558453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449533613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602471905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536327650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454774001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915762923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747742929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978496797"/>
                    </a:ext>
                  </a:extLst>
                </a:gridCol>
              </a:tblGrid>
              <a:tr h="376396"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HBLV sestrin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HBLV contro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9317797"/>
                  </a:ext>
                </a:extLst>
              </a:tr>
              <a:tr h="376396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1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1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6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1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2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1870760"/>
                  </a:ext>
                </a:extLst>
              </a:tr>
              <a:tr h="376396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9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8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0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9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8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38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1302630"/>
                  </a:ext>
                </a:extLst>
              </a:tr>
              <a:tr h="376396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64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64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64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2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0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4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3059417"/>
                  </a:ext>
                </a:extLst>
              </a:tr>
              <a:tr h="376396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02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.12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92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48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52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44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88149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243292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8</TotalTime>
  <Words>528</Words>
  <Application>Microsoft Office PowerPoint</Application>
  <PresentationFormat>宽屏</PresentationFormat>
  <Paragraphs>470</Paragraphs>
  <Slides>1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4</vt:i4>
      </vt:variant>
    </vt:vector>
  </HeadingPairs>
  <TitlesOfParts>
    <vt:vector size="1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汤 臻</dc:creator>
  <cp:lastModifiedBy>汤 臻</cp:lastModifiedBy>
  <cp:revision>22</cp:revision>
  <dcterms:created xsi:type="dcterms:W3CDTF">2021-06-15T01:43:45Z</dcterms:created>
  <dcterms:modified xsi:type="dcterms:W3CDTF">2021-06-15T07:57:27Z</dcterms:modified>
</cp:coreProperties>
</file>